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12192000" cy="6858000"/>
  <p:notesSz cx="7104063" cy="10234613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199" y="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capçaler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3" name="Contenidor de data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AF237C-6584-442F-BD10-BEC4A967F527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4" name="Contenidor d'imatge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a-ES"/>
          </a:p>
        </p:txBody>
      </p:sp>
      <p:sp>
        <p:nvSpPr>
          <p:cNvPr id="5" name="Contenidor de notes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85CC3-77BB-4B80-84F7-C7C38872ADFB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5983594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F38A2296-94B6-4DA9-A261-3F25BB9128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1ED43EC7-91CA-4600-B9A1-48C797FD4A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2659B684-8C79-462B-A6F2-2A6137CB0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3EAD2F6F-C066-4E63-89C6-114C91B31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4287C947-BA37-434F-955C-E88339A9E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34373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36899C77-F3FC-46D9-BDF4-582C33C921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98BFE663-0921-4FA8-B323-2170D3B59A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943C0CF2-30C5-49A8-9646-B5596BA1B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AF47C2B3-6589-4C34-8CC3-50585437A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7088749F-2099-43DE-AF07-DDF3DED28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936205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BBC23AF4-F299-4746-A5EA-8A302B450E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511C6C7A-3C68-4DB7-A944-EDEBF2DFFB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9BCA2D7E-3FDD-47BB-B60F-8C8F76ED1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45B4E95A-BAEE-48E4-B558-5372D1AEB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B3DDDD18-D73A-4653-8A87-F8BBD64E4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361987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52BB7F2-B0BD-4769-A698-3E489F0F28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AE5D4008-8585-4148-848B-7092FF43F9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F92DE8A8-003B-44EF-B2D7-F91C68032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875E0D27-D379-45C7-B124-CCAB7C579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04614434-71DD-470A-831C-B738950CA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564542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D0327481-EF3F-4962-A3CD-8C0AFB4247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A878C3AC-4DDB-40E5-8384-D0FA5AAA69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A3BCBA74-5231-4B35-B7E4-6A6861A0B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AA37018B-5C81-4DEB-A9DF-785BF56AE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970F2321-31C1-4342-A69B-225692F89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745094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9118DE0B-19E2-4FE8-802A-A4B9589D4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9019DB87-2FA5-4E18-A279-2DB97B4474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EE1C47B1-8C06-4B32-A705-9F618A3069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30C62D1F-2ABE-49FF-B398-B67C50F56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D12471D8-C437-4109-8D1A-7E1A0D8E7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F02E883A-41F8-4C2D-82C4-C256E86E4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77976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91BE4A5A-0D05-4795-824C-C3C366F4C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BA5FDA76-20B9-4A02-B5EF-F0280D7E72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AA6C3416-8C1A-4DF2-9198-1E6707546E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A7A2139E-E531-4171-8A00-BCF842E168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E78BC7E8-4300-4127-BEC8-FC23715DF3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A8944FFB-AC0B-4C1F-BF76-06633C0B3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2F9AEB8D-A2AE-40EB-B140-0BCD1FDE6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B0C11875-A90C-48CC-A694-23F58B001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68487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4E0D4F27-23D6-43AE-893F-8EE8F52E35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0726441B-3450-43B3-AF21-43FF78C01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38FAD161-F217-46EC-ABBD-228F161C3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A8CE4142-3696-420A-9BE6-090EC27B2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274895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99AB7CF3-6857-4C8B-90AA-DA3E8E54B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71498ACC-952E-40AE-B79E-0CB788A28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FEC478D0-3106-4D5E-90C4-74329625D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562969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4C3B8066-CCBA-4ED9-871A-BB5C91EB9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CF8EF0DD-A6DE-4170-BBF2-B54DC5C90F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09A26614-124F-4D16-B278-D1FB79BD14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003DA928-0ABD-4397-A361-D57E06C6E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938176BC-4B86-4CAC-8B2F-1B76567AD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075C0612-728A-48F7-898E-0E37FC5BF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317479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DF87A433-101D-49B9-9932-24BE4920DF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E32B9D7E-C9A1-413A-8830-F02BDAECEB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311CF9C5-876D-4C8D-A7C6-165ED1F82D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Editeu els estils de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048DE4B4-9E5F-4F49-9725-19C339F83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3F9F2548-2D50-44D8-B730-A1BFB73C8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F22EFDA2-7E83-4E9F-90FB-9ECC6F38F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376254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A15F3D19-C8C9-423E-A241-671464A437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67C5397A-8E63-4C10-9849-95ECEC4175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Editeu els estils de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B6FB24CF-8A79-485A-B621-34744B6DE0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BCAF9-1E6B-4B19-8417-65DC89FB2CE4}" type="datetimeFigureOut">
              <a:rPr lang="ca-ES" smtClean="0"/>
              <a:t>22/4/2025</a:t>
            </a:fld>
            <a:endParaRPr lang="ca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9A34FA4C-978B-4F1A-A595-B702A7E09C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196B38C8-6386-477E-B317-D59FDF96E8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AB939-F686-4FC6-BB60-72B423F7D1A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0453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969" y="213569"/>
            <a:ext cx="11444621" cy="5303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2 CuadroTexto"/>
          <p:cNvSpPr txBox="1"/>
          <p:nvPr/>
        </p:nvSpPr>
        <p:spPr>
          <a:xfrm>
            <a:off x="278969" y="5590546"/>
            <a:ext cx="1176321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/>
              <a:t>Supplementary</a:t>
            </a:r>
            <a:r>
              <a:rPr lang="es-ES" sz="1400" b="1" dirty="0"/>
              <a:t> Figure </a:t>
            </a:r>
            <a:r>
              <a:rPr lang="en-US" altLang="zh-CN" sz="1400" b="1"/>
              <a:t>S</a:t>
            </a:r>
            <a:r>
              <a:rPr lang="es-ES" sz="1400" b="1"/>
              <a:t>1</a:t>
            </a:r>
            <a:r>
              <a:rPr lang="es-ES" sz="1400" b="1" dirty="0"/>
              <a:t>: </a:t>
            </a:r>
            <a:r>
              <a:rPr lang="en-US" sz="1400" b="1" dirty="0"/>
              <a:t>Expression and mean fluorescence intensity of surface markers on PLTs, aggregated PLTs, and PMPs. </a:t>
            </a:r>
            <a:r>
              <a:rPr lang="en-US" sz="1400" dirty="0"/>
              <a:t>Left side of each graph: Percentage of PLTs, aggregated PLTs, and PMPs expressing CD36, CD63, CD40L, PAC1, and CD147. Right side of each graph: Mean fluorescence intensity (MFI) of CD36, CD63, CD40L, PAC1, and CD147 on PLTs, aggregated PLTs, and PMPs. Statistical analysis was performed using the Mann-Whitney test.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38545909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icin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icin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0</TotalTime>
  <Words>9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l'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Silvia Vidal Alcorisa</dc:creator>
  <cp:lastModifiedBy>MDPI</cp:lastModifiedBy>
  <cp:revision>40</cp:revision>
  <cp:lastPrinted>2024-12-12T13:28:38Z</cp:lastPrinted>
  <dcterms:created xsi:type="dcterms:W3CDTF">2024-08-20T08:50:34Z</dcterms:created>
  <dcterms:modified xsi:type="dcterms:W3CDTF">2025-04-22T13:36:33Z</dcterms:modified>
</cp:coreProperties>
</file>